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1D2A0A-E991-43D1-A344-269E10A942E5}" v="2" dt="2025-11-02T21:55:58.218"/>
    <p1510:client id="{BFB157A3-EDF0-45F6-ABC2-3EFB301C0595}" v="3" dt="2025-11-02T21:18:48.04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96" y="3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custSel addSld modSld">
      <pc:chgData name="Sobel, Raymond" userId="682ea7fd-2081-4ef7-9ccf-cc036b672067" providerId="ADAL" clId="{327064EF-D6E0-4CA7-937D-5219C7D36AD4}" dt="2025-11-02T21:57:16.373" v="152" actId="6549"/>
      <pc:docMkLst>
        <pc:docMk/>
      </pc:docMkLst>
      <pc:sldChg chg="addSp delSp modSp new mod">
        <pc:chgData name="Sobel, Raymond" userId="682ea7fd-2081-4ef7-9ccf-cc036b672067" providerId="ADAL" clId="{327064EF-D6E0-4CA7-937D-5219C7D36AD4}" dt="2025-11-02T21:57:16.373" v="152" actId="6549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1:57:16.373" v="152" actId="6549"/>
          <ac:spMkLst>
            <pc:docMk/>
            <pc:sldMk cId="3744564216" sldId="256"/>
            <ac:spMk id="4" creationId="{2571C028-8524-3A49-B9BB-8EE9AB795E3A}"/>
          </ac:spMkLst>
        </pc:spChg>
        <pc:picChg chg="add del mod">
          <ac:chgData name="Sobel, Raymond" userId="682ea7fd-2081-4ef7-9ccf-cc036b672067" providerId="ADAL" clId="{327064EF-D6E0-4CA7-937D-5219C7D36AD4}" dt="2025-11-02T21:55:35.294" v="138" actId="478"/>
          <ac:picMkLst>
            <pc:docMk/>
            <pc:sldMk cId="3744564216" sldId="256"/>
            <ac:picMk id="3" creationId="{A11ABE44-0B99-3AE0-A94A-378154AA6F58}"/>
          </ac:picMkLst>
        </pc:picChg>
        <pc:picChg chg="add mod">
          <ac:chgData name="Sobel, Raymond" userId="682ea7fd-2081-4ef7-9ccf-cc036b672067" providerId="ADAL" clId="{327064EF-D6E0-4CA7-937D-5219C7D36AD4}" dt="2025-11-02T21:55:58.218" v="143"/>
          <ac:picMkLst>
            <pc:docMk/>
            <pc:sldMk cId="3744564216" sldId="256"/>
            <ac:picMk id="5" creationId="{0658BD1B-096F-EFAC-5D13-8EF266FF64F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311889" y="5011484"/>
            <a:ext cx="1168872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Histopathological findings in muscle biopsy from the patient c. Light microscopy analysis demonstrated: (A) low fiber size variability, numerous fibers containing multiple cytoplasmic vacuoles, internalized nuclei, fiber splitting, and low increased endomysial connective tissue; (B) a granular or dotted aspect of the muscle cell membrane and red labeling of cytoplasmic vacuoles; (C) absence of myofibrillar disorganization and no accumulation of mitochondria in the periphery of the fibers; (D, E) no predominance of fiber type but selective atrophy of type II fibers; (F). Abbreviations: GT, Gömöri trichrome; H&amp;E, hematoxylin and eosin; NADH-TR, reduced nicotinamide adenine dinucleotide dehydrogenase-tetrazolium reductase. Scale bar = 100 µm for all panels</a:t>
            </a:r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658BD1B-096F-EFAC-5D13-8EF266FF64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70279" y="319285"/>
            <a:ext cx="8841638" cy="4446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4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1:57:19Z</dcterms:modified>
</cp:coreProperties>
</file>